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144018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9" d="100"/>
          <a:sy n="39" d="100"/>
        </p:scale>
        <p:origin x="-3210" y="-126"/>
      </p:cViewPr>
      <p:guideLst>
        <p:guide orient="horz" pos="4536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4473893"/>
            <a:ext cx="5829300" cy="308705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8161020"/>
            <a:ext cx="4800600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1210153"/>
            <a:ext cx="1157288" cy="2580655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1210153"/>
            <a:ext cx="3357563" cy="2580655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9254491"/>
            <a:ext cx="5829300" cy="286035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6104098"/>
            <a:ext cx="5829300" cy="315039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7057550"/>
            <a:ext cx="2257425" cy="1995916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7057550"/>
            <a:ext cx="2257425" cy="1995916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576740"/>
            <a:ext cx="6172200" cy="24003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3223737"/>
            <a:ext cx="3030141" cy="13435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4567237"/>
            <a:ext cx="3030141" cy="829770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3223737"/>
            <a:ext cx="3031331" cy="13435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4567237"/>
            <a:ext cx="3031331" cy="829770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573405"/>
            <a:ext cx="2256235" cy="244030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573406"/>
            <a:ext cx="3833813" cy="1229153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3013711"/>
            <a:ext cx="2256235" cy="985123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10081260"/>
            <a:ext cx="4114800" cy="1190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1286828"/>
            <a:ext cx="4114800" cy="86410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11271410"/>
            <a:ext cx="4114800" cy="169021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576740"/>
            <a:ext cx="6172200" cy="24003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3360421"/>
            <a:ext cx="6172200" cy="950452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13348336"/>
            <a:ext cx="1600200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A4886-81A7-489F-8C98-1B412C216561}" type="datetimeFigureOut">
              <a:rPr lang="en-US" smtClean="0"/>
              <a:pPr/>
              <a:t>12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13348336"/>
            <a:ext cx="2171700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13348336"/>
            <a:ext cx="1600200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4A8669-3E41-48DF-84A3-A53E2CE1FE28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71546" y="293811"/>
            <a:ext cx="4946637" cy="1390801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248013" y="348317"/>
            <a:ext cx="281207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503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252760" y="738867"/>
            <a:ext cx="2643756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</a:t>
            </a:r>
            <a:r>
              <a:rPr lang="en-GB" sz="1000" i="1" dirty="0" err="1" smtClean="0">
                <a:cs typeface="Microsoft Sans Serif" pitchFamily="34" charset="0"/>
              </a:rPr>
              <a:t>exiguus</a:t>
            </a:r>
            <a:r>
              <a:rPr lang="en-GB" sz="1000" dirty="0" smtClean="0">
                <a:cs typeface="Microsoft Sans Serif" pitchFamily="34" charset="0"/>
              </a:rPr>
              <a:t> DSM 14696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48013" y="543576"/>
            <a:ext cx="281207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558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57522" y="2134279"/>
            <a:ext cx="269505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</a:t>
            </a:r>
            <a:r>
              <a:rPr lang="en-GB" sz="1000" i="1" dirty="0" err="1" smtClean="0">
                <a:cs typeface="Microsoft Sans Serif" pitchFamily="34" charset="0"/>
              </a:rPr>
              <a:t>exiguus</a:t>
            </a:r>
            <a:r>
              <a:rPr lang="en-GB" sz="1000" dirty="0" smtClean="0">
                <a:cs typeface="Microsoft Sans Serif" pitchFamily="34" charset="0"/>
              </a:rPr>
              <a:t> DSM 14696</a:t>
            </a:r>
            <a:r>
              <a:rPr lang="en-GB" sz="1000" baseline="30000" dirty="0" smtClean="0">
                <a:cs typeface="Microsoft Sans Serif" pitchFamily="34" charset="0"/>
              </a:rPr>
              <a:t>T</a:t>
            </a:r>
            <a:endParaRPr lang="en-GB" sz="1000" baseline="30000" dirty="0">
              <a:cs typeface="Microsoft Sans Serif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57535" y="2520016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499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76583" y="3329638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92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90873" y="3524899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25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62297" y="3724924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307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52772" y="3920185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502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233723" y="4110687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497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262298" y="4315477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2259</a:t>
            </a:r>
            <a:endParaRPr lang="en-GB" sz="1000" baseline="30000" dirty="0">
              <a:cs typeface="Microsoft Sans Serif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52772" y="4515497"/>
            <a:ext cx="2906649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NBRC 100086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248010" y="4715529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27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90872" y="4910786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379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81348" y="5110816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51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43232" y="5901391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82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286109" y="6101418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359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305159" y="6296704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557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290870" y="6496733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548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286109" y="6696760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547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262298" y="6887270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39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267060" y="7077770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20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267061" y="7273047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43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290873" y="8077911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298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267061" y="8277935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500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81342" y="9259022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501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281343" y="9459047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25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276579" y="9659079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19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081315" y="9863862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35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086078" y="10078202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301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086078" y="10278232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615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109892" y="10654470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33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095602" y="11235496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08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119400" y="11445048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61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119387" y="11645083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1434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281311" y="12830947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498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267023" y="12635685"/>
            <a:ext cx="2796041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Corallococcus coralloides </a:t>
            </a:r>
            <a:r>
              <a:rPr lang="en-GB" sz="1000" dirty="0" smtClean="0">
                <a:cs typeface="Microsoft Sans Serif" pitchFamily="34" charset="0"/>
              </a:rPr>
              <a:t>DSM 52496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23020" y="13227750"/>
            <a:ext cx="2521928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err="1" smtClean="0">
                <a:cs typeface="Microsoft Sans Serif" pitchFamily="34" charset="0"/>
              </a:rPr>
              <a:t>Archangium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i="1" dirty="0" err="1" smtClean="0">
                <a:cs typeface="Microsoft Sans Serif" pitchFamily="34" charset="0"/>
              </a:rPr>
              <a:t>gephyra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dirty="0" smtClean="0">
                <a:cs typeface="Microsoft Sans Serif" pitchFamily="34" charset="0"/>
              </a:rPr>
              <a:t>DSM 2261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286930" y="13026187"/>
            <a:ext cx="2461014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err="1" smtClean="0">
                <a:cs typeface="Microsoft Sans Serif" pitchFamily="34" charset="0"/>
              </a:rPr>
              <a:t>Pyxidicoccus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i="1" dirty="0" err="1" smtClean="0">
                <a:cs typeface="Microsoft Sans Serif" pitchFamily="34" charset="0"/>
              </a:rPr>
              <a:t>fallax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dirty="0" smtClean="0">
                <a:cs typeface="Microsoft Sans Serif" pitchFamily="34" charset="0"/>
              </a:rPr>
              <a:t>DSM 14698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190009" y="12432032"/>
            <a:ext cx="2469028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Myxococcus </a:t>
            </a:r>
            <a:r>
              <a:rPr lang="en-GB" sz="1000" i="1" dirty="0" err="1" smtClean="0">
                <a:cs typeface="Microsoft Sans Serif" pitchFamily="34" charset="0"/>
              </a:rPr>
              <a:t>fulvus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dirty="0" smtClean="0">
                <a:cs typeface="Microsoft Sans Serif" pitchFamily="34" charset="0"/>
              </a:rPr>
              <a:t>DSM 16525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291844" y="11842798"/>
            <a:ext cx="2574827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Myxococcus xanthus </a:t>
            </a:r>
            <a:r>
              <a:rPr lang="en-GB" sz="1000" dirty="0" smtClean="0">
                <a:cs typeface="Microsoft Sans Serif" pitchFamily="34" charset="0"/>
              </a:rPr>
              <a:t>DSM 16526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233550" y="12037339"/>
            <a:ext cx="2831307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Myxococcus macrosporus </a:t>
            </a:r>
            <a:r>
              <a:rPr lang="en-GB" sz="1000" dirty="0" smtClean="0">
                <a:cs typeface="Microsoft Sans Serif" pitchFamily="34" charset="0"/>
              </a:rPr>
              <a:t>DSM 14697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225821" y="12236092"/>
            <a:ext cx="264696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smtClean="0">
                <a:cs typeface="Microsoft Sans Serif" pitchFamily="34" charset="0"/>
              </a:rPr>
              <a:t>Myxococcus </a:t>
            </a:r>
            <a:r>
              <a:rPr lang="en-GB" sz="1000" i="1" dirty="0" err="1" smtClean="0">
                <a:cs typeface="Microsoft Sans Serif" pitchFamily="34" charset="0"/>
              </a:rPr>
              <a:t>stipitatus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dirty="0" smtClean="0">
                <a:cs typeface="Microsoft Sans Serif" pitchFamily="34" charset="0"/>
              </a:rPr>
              <a:t>DSM 14675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324852" y="13620348"/>
            <a:ext cx="2494676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err="1" smtClean="0">
                <a:cs typeface="Microsoft Sans Serif" pitchFamily="34" charset="0"/>
              </a:rPr>
              <a:t>Polyangium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i="1" dirty="0" err="1" smtClean="0">
                <a:cs typeface="Microsoft Sans Serif" pitchFamily="34" charset="0"/>
              </a:rPr>
              <a:t>cellulosum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dirty="0" smtClean="0">
                <a:cs typeface="Microsoft Sans Serif" pitchFamily="34" charset="0"/>
              </a:rPr>
              <a:t>So ce90</a:t>
            </a:r>
            <a:endParaRPr lang="en-GB" sz="1000" dirty="0">
              <a:cs typeface="Microsoft Sans Serif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291836" y="13427200"/>
            <a:ext cx="2698258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rIns="864000" rtlCol="0">
            <a:spAutoFit/>
          </a:bodyPr>
          <a:lstStyle/>
          <a:p>
            <a:r>
              <a:rPr lang="en-GB" sz="1000" i="1" dirty="0" err="1" smtClean="0">
                <a:cs typeface="Microsoft Sans Serif" pitchFamily="34" charset="0"/>
              </a:rPr>
              <a:t>Vitiosangium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i="1" dirty="0" err="1" smtClean="0">
                <a:cs typeface="Microsoft Sans Serif" pitchFamily="34" charset="0"/>
              </a:rPr>
              <a:t>subalbum</a:t>
            </a:r>
            <a:r>
              <a:rPr lang="en-GB" sz="1000" i="1" dirty="0" smtClean="0">
                <a:cs typeface="Microsoft Sans Serif" pitchFamily="34" charset="0"/>
              </a:rPr>
              <a:t> </a:t>
            </a:r>
            <a:r>
              <a:rPr lang="en-GB" sz="1000" dirty="0" err="1" smtClean="0">
                <a:cs typeface="Microsoft Sans Serif" pitchFamily="34" charset="0"/>
              </a:rPr>
              <a:t>MCy</a:t>
            </a:r>
            <a:r>
              <a:rPr lang="en-GB" sz="1000" dirty="0" smtClean="0">
                <a:cs typeface="Microsoft Sans Serif" pitchFamily="34" charset="0"/>
              </a:rPr>
              <a:t> 10944</a:t>
            </a:r>
            <a:endParaRPr lang="en-GB" sz="1000" dirty="0">
              <a:cs typeface="Microsoft Sans Serif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180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e</dc:creator>
  <cp:lastModifiedBy>Dave</cp:lastModifiedBy>
  <cp:revision>6</cp:revision>
  <dcterms:created xsi:type="dcterms:W3CDTF">2018-06-29T14:46:46Z</dcterms:created>
  <dcterms:modified xsi:type="dcterms:W3CDTF">2018-12-09T15:54:09Z</dcterms:modified>
</cp:coreProperties>
</file>